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4"/>
  </p:notesMasterIdLst>
  <p:sldIdLst>
    <p:sldId id="286" r:id="rId2"/>
    <p:sldId id="288" r:id="rId3"/>
    <p:sldId id="289" r:id="rId4"/>
    <p:sldId id="291" r:id="rId5"/>
    <p:sldId id="293" r:id="rId6"/>
    <p:sldId id="300" r:id="rId7"/>
    <p:sldId id="287" r:id="rId8"/>
    <p:sldId id="298" r:id="rId9"/>
    <p:sldId id="282" r:id="rId10"/>
    <p:sldId id="283" r:id="rId11"/>
    <p:sldId id="284" r:id="rId12"/>
    <p:sldId id="281" r:id="rId13"/>
  </p:sldIdLst>
  <p:sldSz cx="12192000" cy="68580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28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D9F0A0F-EE5D-47E2-58D7-85464988C312}" name="McManaman, Jim" initials="MJ" userId="S::jim.mcmanaman@cuanschutz.edu::9384fe1f-9d2f-48d5-ac36-980c9eceafc6" providerId="AD"/>
  <p188:author id="{D322FA7F-76C1-9BCA-ECA5-F165B737B0FE}" name="Martin Carli, Jayne" initials="MCJ" userId="S::JAYNE.MARTINCARLI@CUANSCHUTZ.EDU::e3e07b16-903a-4611-9401-85df4cb498fa" providerId="AD"/>
  <p188:author id="{C6A300DE-161B-CFAC-B2C7-01148E174299}" name="Martin Carli, Jayne" initials="JM" userId="S::jayne.martincarli@cuanschutz.edu::e3e07b16-903a-4611-9401-85df4cb498fa" providerId="AD"/>
  <p188:author id="{6F7474F0-A28C-02F8-795B-1D81671A73D9}" name="Monks, Jenifer" initials="MJ" userId="S::jenifer.monks@cuanschutz.edu::4faa74fe-392b-44a3-828b-2f3b1c4f77e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CC"/>
    <a:srgbClr val="FF7C80"/>
    <a:srgbClr val="FF3399"/>
    <a:srgbClr val="9AD8A1"/>
    <a:srgbClr val="DC7AA1"/>
    <a:srgbClr val="2D2F45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3C59396-26E5-4F72-84E4-FBB686C76A36}" v="17" dt="2023-09-20T18:24:34.27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1186" autoAdjust="0"/>
  </p:normalViewPr>
  <p:slideViewPr>
    <p:cSldViewPr snapToGrid="0">
      <p:cViewPr>
        <p:scale>
          <a:sx n="87" d="100"/>
          <a:sy n="87" d="100"/>
        </p:scale>
        <p:origin x="499" y="67"/>
      </p:cViewPr>
      <p:guideLst>
        <p:guide orient="horz" pos="1128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microsoft.com/office/2018/10/relationships/authors" Target="author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tin Carli, Jayne" userId="e3e07b16-903a-4611-9401-85df4cb498fa" providerId="ADAL" clId="{E3C59396-26E5-4F72-84E4-FBB686C76A36}"/>
    <pc:docChg chg="undo custSel delSld modSld">
      <pc:chgData name="Martin Carli, Jayne" userId="e3e07b16-903a-4611-9401-85df4cb498fa" providerId="ADAL" clId="{E3C59396-26E5-4F72-84E4-FBB686C76A36}" dt="2023-09-20T22:25:47.817" v="1326" actId="6549"/>
      <pc:docMkLst>
        <pc:docMk/>
      </pc:docMkLst>
      <pc:sldChg chg="del">
        <pc:chgData name="Martin Carli, Jayne" userId="e3e07b16-903a-4611-9401-85df4cb498fa" providerId="ADAL" clId="{E3C59396-26E5-4F72-84E4-FBB686C76A36}" dt="2023-09-15T21:32:08.870" v="0" actId="47"/>
        <pc:sldMkLst>
          <pc:docMk/>
          <pc:sldMk cId="2578889024" sldId="256"/>
        </pc:sldMkLst>
      </pc:sldChg>
      <pc:sldChg chg="del">
        <pc:chgData name="Martin Carli, Jayne" userId="e3e07b16-903a-4611-9401-85df4cb498fa" providerId="ADAL" clId="{E3C59396-26E5-4F72-84E4-FBB686C76A36}" dt="2023-09-15T21:32:08.870" v="0" actId="47"/>
        <pc:sldMkLst>
          <pc:docMk/>
          <pc:sldMk cId="1550340441" sldId="258"/>
        </pc:sldMkLst>
      </pc:sldChg>
      <pc:sldChg chg="del">
        <pc:chgData name="Martin Carli, Jayne" userId="e3e07b16-903a-4611-9401-85df4cb498fa" providerId="ADAL" clId="{E3C59396-26E5-4F72-84E4-FBB686C76A36}" dt="2023-09-15T21:32:08.870" v="0" actId="47"/>
        <pc:sldMkLst>
          <pc:docMk/>
          <pc:sldMk cId="791515617" sldId="269"/>
        </pc:sldMkLst>
      </pc:sldChg>
      <pc:sldChg chg="del">
        <pc:chgData name="Martin Carli, Jayne" userId="e3e07b16-903a-4611-9401-85df4cb498fa" providerId="ADAL" clId="{E3C59396-26E5-4F72-84E4-FBB686C76A36}" dt="2023-09-15T21:32:08.870" v="0" actId="47"/>
        <pc:sldMkLst>
          <pc:docMk/>
          <pc:sldMk cId="4110537790" sldId="270"/>
        </pc:sldMkLst>
      </pc:sldChg>
      <pc:sldChg chg="del">
        <pc:chgData name="Martin Carli, Jayne" userId="e3e07b16-903a-4611-9401-85df4cb498fa" providerId="ADAL" clId="{E3C59396-26E5-4F72-84E4-FBB686C76A36}" dt="2023-09-15T21:32:08.870" v="0" actId="47"/>
        <pc:sldMkLst>
          <pc:docMk/>
          <pc:sldMk cId="3988882250" sldId="275"/>
        </pc:sldMkLst>
      </pc:sldChg>
      <pc:sldChg chg="del">
        <pc:chgData name="Martin Carli, Jayne" userId="e3e07b16-903a-4611-9401-85df4cb498fa" providerId="ADAL" clId="{E3C59396-26E5-4F72-84E4-FBB686C76A36}" dt="2023-09-15T21:32:08.870" v="0" actId="47"/>
        <pc:sldMkLst>
          <pc:docMk/>
          <pc:sldMk cId="4105797004" sldId="278"/>
        </pc:sldMkLst>
      </pc:sldChg>
      <pc:sldChg chg="del">
        <pc:chgData name="Martin Carli, Jayne" userId="e3e07b16-903a-4611-9401-85df4cb498fa" providerId="ADAL" clId="{E3C59396-26E5-4F72-84E4-FBB686C76A36}" dt="2023-09-15T21:32:08.870" v="0" actId="47"/>
        <pc:sldMkLst>
          <pc:docMk/>
          <pc:sldMk cId="741510763" sldId="279"/>
        </pc:sldMkLst>
      </pc:sldChg>
      <pc:sldChg chg="addSp delSp modSp mod modNotesTx">
        <pc:chgData name="Martin Carli, Jayne" userId="e3e07b16-903a-4611-9401-85df4cb498fa" providerId="ADAL" clId="{E3C59396-26E5-4F72-84E4-FBB686C76A36}" dt="2023-09-20T22:25:47.817" v="1326" actId="6549"/>
        <pc:sldMkLst>
          <pc:docMk/>
          <pc:sldMk cId="643647220" sldId="281"/>
        </pc:sldMkLst>
        <pc:spChg chg="del">
          <ac:chgData name="Martin Carli, Jayne" userId="e3e07b16-903a-4611-9401-85df4cb498fa" providerId="ADAL" clId="{E3C59396-26E5-4F72-84E4-FBB686C76A36}" dt="2023-09-15T21:34:43.444" v="11" actId="478"/>
          <ac:spMkLst>
            <pc:docMk/>
            <pc:sldMk cId="643647220" sldId="281"/>
            <ac:spMk id="5" creationId="{C0DFB16E-8401-341E-793E-35E2E81FD65F}"/>
          </ac:spMkLst>
        </pc:spChg>
        <pc:spChg chg="mod">
          <ac:chgData name="Martin Carli, Jayne" userId="e3e07b16-903a-4611-9401-85df4cb498fa" providerId="ADAL" clId="{E3C59396-26E5-4F72-84E4-FBB686C76A36}" dt="2023-09-15T22:50:05.932" v="58" actId="207"/>
          <ac:spMkLst>
            <pc:docMk/>
            <pc:sldMk cId="643647220" sldId="281"/>
            <ac:spMk id="7" creationId="{EEDBFAE8-CA5A-18F5-5DDF-782EC2240808}"/>
          </ac:spMkLst>
        </pc:spChg>
        <pc:picChg chg="del">
          <ac:chgData name="Martin Carli, Jayne" userId="e3e07b16-903a-4611-9401-85df4cb498fa" providerId="ADAL" clId="{E3C59396-26E5-4F72-84E4-FBB686C76A36}" dt="2023-09-15T21:35:15.640" v="13" actId="478"/>
          <ac:picMkLst>
            <pc:docMk/>
            <pc:sldMk cId="643647220" sldId="281"/>
            <ac:picMk id="3" creationId="{468C85EA-A26F-33FA-2E2C-06E5C73FDEBE}"/>
          </ac:picMkLst>
        </pc:picChg>
        <pc:picChg chg="add del mod">
          <ac:chgData name="Martin Carli, Jayne" userId="e3e07b16-903a-4611-9401-85df4cb498fa" providerId="ADAL" clId="{E3C59396-26E5-4F72-84E4-FBB686C76A36}" dt="2023-09-15T22:48:10.036" v="38" actId="478"/>
          <ac:picMkLst>
            <pc:docMk/>
            <pc:sldMk cId="643647220" sldId="281"/>
            <ac:picMk id="3" creationId="{FA5F9AFA-D2FE-FBA1-4D08-3D23E1124EAE}"/>
          </ac:picMkLst>
        </pc:picChg>
        <pc:picChg chg="add del mod">
          <ac:chgData name="Martin Carli, Jayne" userId="e3e07b16-903a-4611-9401-85df4cb498fa" providerId="ADAL" clId="{E3C59396-26E5-4F72-84E4-FBB686C76A36}" dt="2023-09-15T22:49:12.197" v="46" actId="478"/>
          <ac:picMkLst>
            <pc:docMk/>
            <pc:sldMk cId="643647220" sldId="281"/>
            <ac:picMk id="4" creationId="{8C1FB653-4A95-59D7-BA16-DBC14177EC4F}"/>
          </ac:picMkLst>
        </pc:picChg>
        <pc:picChg chg="add mod modCrop">
          <ac:chgData name="Martin Carli, Jayne" userId="e3e07b16-903a-4611-9401-85df4cb498fa" providerId="ADAL" clId="{E3C59396-26E5-4F72-84E4-FBB686C76A36}" dt="2023-09-15T22:49:51.413" v="56" actId="14100"/>
          <ac:picMkLst>
            <pc:docMk/>
            <pc:sldMk cId="643647220" sldId="281"/>
            <ac:picMk id="6" creationId="{6DAA0C33-CCB7-426D-9541-7902AD6B938F}"/>
          </ac:picMkLst>
        </pc:picChg>
        <pc:picChg chg="add del mod">
          <ac:chgData name="Martin Carli, Jayne" userId="e3e07b16-903a-4611-9401-85df4cb498fa" providerId="ADAL" clId="{E3C59396-26E5-4F72-84E4-FBB686C76A36}" dt="2023-09-15T21:37:37.446" v="19" actId="478"/>
          <ac:picMkLst>
            <pc:docMk/>
            <pc:sldMk cId="643647220" sldId="281"/>
            <ac:picMk id="8" creationId="{2282022F-0898-72EE-6E06-AA249EB35F1E}"/>
          </ac:picMkLst>
        </pc:picChg>
        <pc:picChg chg="add del mod">
          <ac:chgData name="Martin Carli, Jayne" userId="e3e07b16-903a-4611-9401-85df4cb498fa" providerId="ADAL" clId="{E3C59396-26E5-4F72-84E4-FBB686C76A36}" dt="2023-09-15T21:39:00.277" v="22" actId="478"/>
          <ac:picMkLst>
            <pc:docMk/>
            <pc:sldMk cId="643647220" sldId="281"/>
            <ac:picMk id="10" creationId="{F68E4E7A-1232-DEF8-4C73-EE97335DB69C}"/>
          </ac:picMkLst>
        </pc:picChg>
      </pc:sldChg>
      <pc:sldChg chg="modSp mod modNotesTx">
        <pc:chgData name="Martin Carli, Jayne" userId="e3e07b16-903a-4611-9401-85df4cb498fa" providerId="ADAL" clId="{E3C59396-26E5-4F72-84E4-FBB686C76A36}" dt="2023-09-20T22:25:30.912" v="1323" actId="6549"/>
        <pc:sldMkLst>
          <pc:docMk/>
          <pc:sldMk cId="3716555165" sldId="282"/>
        </pc:sldMkLst>
        <pc:spChg chg="mod">
          <ac:chgData name="Martin Carli, Jayne" userId="e3e07b16-903a-4611-9401-85df4cb498fa" providerId="ADAL" clId="{E3C59396-26E5-4F72-84E4-FBB686C76A36}" dt="2023-09-15T21:34:11.832" v="8" actId="207"/>
          <ac:spMkLst>
            <pc:docMk/>
            <pc:sldMk cId="3716555165" sldId="282"/>
            <ac:spMk id="7" creationId="{108A723C-D330-0697-1C6A-C07F65431251}"/>
          </ac:spMkLst>
        </pc:spChg>
        <pc:spChg chg="mod">
          <ac:chgData name="Martin Carli, Jayne" userId="e3e07b16-903a-4611-9401-85df4cb498fa" providerId="ADAL" clId="{E3C59396-26E5-4F72-84E4-FBB686C76A36}" dt="2023-09-15T21:34:11.832" v="8" actId="207"/>
          <ac:spMkLst>
            <pc:docMk/>
            <pc:sldMk cId="3716555165" sldId="282"/>
            <ac:spMk id="8" creationId="{25815400-34E9-1D71-BD32-F75662E84083}"/>
          </ac:spMkLst>
        </pc:spChg>
      </pc:sldChg>
      <pc:sldChg chg="modSp mod modNotesTx">
        <pc:chgData name="Martin Carli, Jayne" userId="e3e07b16-903a-4611-9401-85df4cb498fa" providerId="ADAL" clId="{E3C59396-26E5-4F72-84E4-FBB686C76A36}" dt="2023-09-20T22:25:37.087" v="1324" actId="6549"/>
        <pc:sldMkLst>
          <pc:docMk/>
          <pc:sldMk cId="3695395455" sldId="283"/>
        </pc:sldMkLst>
        <pc:spChg chg="mod">
          <ac:chgData name="Martin Carli, Jayne" userId="e3e07b16-903a-4611-9401-85df4cb498fa" providerId="ADAL" clId="{E3C59396-26E5-4F72-84E4-FBB686C76A36}" dt="2023-09-15T21:34:17.924" v="9" actId="207"/>
          <ac:spMkLst>
            <pc:docMk/>
            <pc:sldMk cId="3695395455" sldId="283"/>
            <ac:spMk id="2" creationId="{D0216F42-E512-606B-9CA0-1B47DBEB85CF}"/>
          </ac:spMkLst>
        </pc:spChg>
      </pc:sldChg>
      <pc:sldChg chg="modSp mod modNotesTx">
        <pc:chgData name="Martin Carli, Jayne" userId="e3e07b16-903a-4611-9401-85df4cb498fa" providerId="ADAL" clId="{E3C59396-26E5-4F72-84E4-FBB686C76A36}" dt="2023-09-20T22:25:40.982" v="1325" actId="6549"/>
        <pc:sldMkLst>
          <pc:docMk/>
          <pc:sldMk cId="4284587334" sldId="284"/>
        </pc:sldMkLst>
        <pc:spChg chg="mod">
          <ac:chgData name="Martin Carli, Jayne" userId="e3e07b16-903a-4611-9401-85df4cb498fa" providerId="ADAL" clId="{E3C59396-26E5-4F72-84E4-FBB686C76A36}" dt="2023-09-15T21:34:36.382" v="10" actId="207"/>
          <ac:spMkLst>
            <pc:docMk/>
            <pc:sldMk cId="4284587334" sldId="284"/>
            <ac:spMk id="4" creationId="{A90DDFA2-96D8-D71F-08F4-BA78BFF725D6}"/>
          </ac:spMkLst>
        </pc:spChg>
      </pc:sldChg>
      <pc:sldChg chg="del">
        <pc:chgData name="Martin Carli, Jayne" userId="e3e07b16-903a-4611-9401-85df4cb498fa" providerId="ADAL" clId="{E3C59396-26E5-4F72-84E4-FBB686C76A36}" dt="2023-09-15T21:32:08.870" v="0" actId="47"/>
        <pc:sldMkLst>
          <pc:docMk/>
          <pc:sldMk cId="2508973195" sldId="285"/>
        </pc:sldMkLst>
      </pc:sldChg>
      <pc:sldChg chg="modNotesTx">
        <pc:chgData name="Martin Carli, Jayne" userId="e3e07b16-903a-4611-9401-85df4cb498fa" providerId="ADAL" clId="{E3C59396-26E5-4F72-84E4-FBB686C76A36}" dt="2023-09-20T22:24:43.171" v="1316" actId="6549"/>
        <pc:sldMkLst>
          <pc:docMk/>
          <pc:sldMk cId="1327609090" sldId="286"/>
        </pc:sldMkLst>
      </pc:sldChg>
      <pc:sldChg chg="addSp modSp mod modNotesTx">
        <pc:chgData name="Martin Carli, Jayne" userId="e3e07b16-903a-4611-9401-85df4cb498fa" providerId="ADAL" clId="{E3C59396-26E5-4F72-84E4-FBB686C76A36}" dt="2023-09-20T22:25:20.061" v="1321" actId="6549"/>
        <pc:sldMkLst>
          <pc:docMk/>
          <pc:sldMk cId="3763007823" sldId="287"/>
        </pc:sldMkLst>
        <pc:spChg chg="mod">
          <ac:chgData name="Martin Carli, Jayne" userId="e3e07b16-903a-4611-9401-85df4cb498fa" providerId="ADAL" clId="{E3C59396-26E5-4F72-84E4-FBB686C76A36}" dt="2023-09-20T17:51:15.528" v="1031" actId="20577"/>
          <ac:spMkLst>
            <pc:docMk/>
            <pc:sldMk cId="3763007823" sldId="287"/>
            <ac:spMk id="2" creationId="{214C5E1A-2F39-B101-2728-2DCD2E897780}"/>
          </ac:spMkLst>
        </pc:spChg>
        <pc:spChg chg="add mod">
          <ac:chgData name="Martin Carli, Jayne" userId="e3e07b16-903a-4611-9401-85df4cb498fa" providerId="ADAL" clId="{E3C59396-26E5-4F72-84E4-FBB686C76A36}" dt="2023-09-20T17:51:12.248" v="1030"/>
          <ac:spMkLst>
            <pc:docMk/>
            <pc:sldMk cId="3763007823" sldId="287"/>
            <ac:spMk id="6" creationId="{2F77C1EE-9C65-89F9-DEC5-703D3DC5E2C8}"/>
          </ac:spMkLst>
        </pc:spChg>
        <pc:spChg chg="add mod">
          <ac:chgData name="Martin Carli, Jayne" userId="e3e07b16-903a-4611-9401-85df4cb498fa" providerId="ADAL" clId="{E3C59396-26E5-4F72-84E4-FBB686C76A36}" dt="2023-09-20T17:51:12.248" v="1030"/>
          <ac:spMkLst>
            <pc:docMk/>
            <pc:sldMk cId="3763007823" sldId="287"/>
            <ac:spMk id="7" creationId="{B0ACD376-0782-7D76-FED4-73754EE7B10B}"/>
          </ac:spMkLst>
        </pc:spChg>
        <pc:picChg chg="add mod">
          <ac:chgData name="Martin Carli, Jayne" userId="e3e07b16-903a-4611-9401-85df4cb498fa" providerId="ADAL" clId="{E3C59396-26E5-4F72-84E4-FBB686C76A36}" dt="2023-09-20T17:51:29.517" v="1087" actId="1037"/>
          <ac:picMkLst>
            <pc:docMk/>
            <pc:sldMk cId="3763007823" sldId="287"/>
            <ac:picMk id="4" creationId="{2E4CEA99-348A-222B-C10C-E89E3AA9132B}"/>
          </ac:picMkLst>
        </pc:picChg>
        <pc:picChg chg="mod">
          <ac:chgData name="Martin Carli, Jayne" userId="e3e07b16-903a-4611-9401-85df4cb498fa" providerId="ADAL" clId="{E3C59396-26E5-4F72-84E4-FBB686C76A36}" dt="2023-09-20T17:51:24.400" v="1065" actId="1037"/>
          <ac:picMkLst>
            <pc:docMk/>
            <pc:sldMk cId="3763007823" sldId="287"/>
            <ac:picMk id="5" creationId="{9A51E6EE-AF4E-AEA6-7141-F011CB1D9193}"/>
          </ac:picMkLst>
        </pc:picChg>
      </pc:sldChg>
      <pc:sldChg chg="modSp mod modNotesTx">
        <pc:chgData name="Martin Carli, Jayne" userId="e3e07b16-903a-4611-9401-85df4cb498fa" providerId="ADAL" clId="{E3C59396-26E5-4F72-84E4-FBB686C76A36}" dt="2023-09-20T22:24:48.071" v="1317" actId="6549"/>
        <pc:sldMkLst>
          <pc:docMk/>
          <pc:sldMk cId="3320246857" sldId="288"/>
        </pc:sldMkLst>
        <pc:spChg chg="mod">
          <ac:chgData name="Martin Carli, Jayne" userId="e3e07b16-903a-4611-9401-85df4cb498fa" providerId="ADAL" clId="{E3C59396-26E5-4F72-84E4-FBB686C76A36}" dt="2023-09-15T21:32:35.531" v="1" actId="207"/>
          <ac:spMkLst>
            <pc:docMk/>
            <pc:sldMk cId="3320246857" sldId="288"/>
            <ac:spMk id="4" creationId="{8224BEDA-6AE1-7284-50E0-DBE113EAF5CF}"/>
          </ac:spMkLst>
        </pc:spChg>
        <pc:spChg chg="mod">
          <ac:chgData name="Martin Carli, Jayne" userId="e3e07b16-903a-4611-9401-85df4cb498fa" providerId="ADAL" clId="{E3C59396-26E5-4F72-84E4-FBB686C76A36}" dt="2023-09-15T21:32:35.531" v="1" actId="207"/>
          <ac:spMkLst>
            <pc:docMk/>
            <pc:sldMk cId="3320246857" sldId="288"/>
            <ac:spMk id="5" creationId="{1DA55F0A-51FB-5D98-3433-05CBAED4562D}"/>
          </ac:spMkLst>
        </pc:spChg>
      </pc:sldChg>
      <pc:sldChg chg="addSp modSp mod modNotesTx">
        <pc:chgData name="Martin Carli, Jayne" userId="e3e07b16-903a-4611-9401-85df4cb498fa" providerId="ADAL" clId="{E3C59396-26E5-4F72-84E4-FBB686C76A36}" dt="2023-09-20T22:24:53.668" v="1318" actId="6549"/>
        <pc:sldMkLst>
          <pc:docMk/>
          <pc:sldMk cId="3700314354" sldId="289"/>
        </pc:sldMkLst>
        <pc:spChg chg="mod">
          <ac:chgData name="Martin Carli, Jayne" userId="e3e07b16-903a-4611-9401-85df4cb498fa" providerId="ADAL" clId="{E3C59396-26E5-4F72-84E4-FBB686C76A36}" dt="2023-09-20T16:53:57.587" v="108" actId="20577"/>
          <ac:spMkLst>
            <pc:docMk/>
            <pc:sldMk cId="3700314354" sldId="289"/>
            <ac:spMk id="2" creationId="{8CB23911-BEA4-25D7-22E8-3B34EE3172A9}"/>
          </ac:spMkLst>
        </pc:spChg>
        <pc:spChg chg="add mod">
          <ac:chgData name="Martin Carli, Jayne" userId="e3e07b16-903a-4611-9401-85df4cb498fa" providerId="ADAL" clId="{E3C59396-26E5-4F72-84E4-FBB686C76A36}" dt="2023-09-20T16:58:01.047" v="453" actId="12789"/>
          <ac:spMkLst>
            <pc:docMk/>
            <pc:sldMk cId="3700314354" sldId="289"/>
            <ac:spMk id="6" creationId="{36229801-2446-CA77-A4EA-488A71E5D9AE}"/>
          </ac:spMkLst>
        </pc:spChg>
        <pc:spChg chg="add mod">
          <ac:chgData name="Martin Carli, Jayne" userId="e3e07b16-903a-4611-9401-85df4cb498fa" providerId="ADAL" clId="{E3C59396-26E5-4F72-84E4-FBB686C76A36}" dt="2023-09-20T16:58:06.698" v="457" actId="1037"/>
          <ac:spMkLst>
            <pc:docMk/>
            <pc:sldMk cId="3700314354" sldId="289"/>
            <ac:spMk id="7" creationId="{C2DAE36E-E388-6646-8783-BA2E6B826488}"/>
          </ac:spMkLst>
        </pc:spChg>
        <pc:picChg chg="add mod">
          <ac:chgData name="Martin Carli, Jayne" userId="e3e07b16-903a-4611-9401-85df4cb498fa" providerId="ADAL" clId="{E3C59396-26E5-4F72-84E4-FBB686C76A36}" dt="2023-09-20T16:55:51.449" v="180" actId="1037"/>
          <ac:picMkLst>
            <pc:docMk/>
            <pc:sldMk cId="3700314354" sldId="289"/>
            <ac:picMk id="4" creationId="{07B7F900-8E2A-4353-700E-9E3AC24B7A9E}"/>
          </ac:picMkLst>
        </pc:picChg>
        <pc:picChg chg="mod">
          <ac:chgData name="Martin Carli, Jayne" userId="e3e07b16-903a-4611-9401-85df4cb498fa" providerId="ADAL" clId="{E3C59396-26E5-4F72-84E4-FBB686C76A36}" dt="2023-09-20T16:57:28.937" v="449" actId="1038"/>
          <ac:picMkLst>
            <pc:docMk/>
            <pc:sldMk cId="3700314354" sldId="289"/>
            <ac:picMk id="5" creationId="{60F9D07E-3A63-4249-5F13-1067120E6A24}"/>
          </ac:picMkLst>
        </pc:picChg>
      </pc:sldChg>
      <pc:sldChg chg="addSp modSp mod modNotesTx">
        <pc:chgData name="Martin Carli, Jayne" userId="e3e07b16-903a-4611-9401-85df4cb498fa" providerId="ADAL" clId="{E3C59396-26E5-4F72-84E4-FBB686C76A36}" dt="2023-09-20T22:25:07.837" v="1319" actId="6549"/>
        <pc:sldMkLst>
          <pc:docMk/>
          <pc:sldMk cId="3450577209" sldId="291"/>
        </pc:sldMkLst>
        <pc:spChg chg="mod">
          <ac:chgData name="Martin Carli, Jayne" userId="e3e07b16-903a-4611-9401-85df4cb498fa" providerId="ADAL" clId="{E3C59396-26E5-4F72-84E4-FBB686C76A36}" dt="2023-09-20T16:56:11.366" v="224" actId="20577"/>
          <ac:spMkLst>
            <pc:docMk/>
            <pc:sldMk cId="3450577209" sldId="291"/>
            <ac:spMk id="2" creationId="{F411F78C-2148-7935-E88F-95153F28CFB2}"/>
          </ac:spMkLst>
        </pc:spChg>
        <pc:spChg chg="add mod">
          <ac:chgData name="Martin Carli, Jayne" userId="e3e07b16-903a-4611-9401-85df4cb498fa" providerId="ADAL" clId="{E3C59396-26E5-4F72-84E4-FBB686C76A36}" dt="2023-09-20T16:58:11.016" v="458"/>
          <ac:spMkLst>
            <pc:docMk/>
            <pc:sldMk cId="3450577209" sldId="291"/>
            <ac:spMk id="5" creationId="{03C4C56A-F199-E778-E922-7FAF3E104E67}"/>
          </ac:spMkLst>
        </pc:spChg>
        <pc:spChg chg="add mod">
          <ac:chgData name="Martin Carli, Jayne" userId="e3e07b16-903a-4611-9401-85df4cb498fa" providerId="ADAL" clId="{E3C59396-26E5-4F72-84E4-FBB686C76A36}" dt="2023-09-20T16:58:11.016" v="458"/>
          <ac:spMkLst>
            <pc:docMk/>
            <pc:sldMk cId="3450577209" sldId="291"/>
            <ac:spMk id="6" creationId="{AFC6F6EC-901D-7220-0624-01AB25EDD898}"/>
          </ac:spMkLst>
        </pc:spChg>
        <pc:picChg chg="add mod">
          <ac:chgData name="Martin Carli, Jayne" userId="e3e07b16-903a-4611-9401-85df4cb498fa" providerId="ADAL" clId="{E3C59396-26E5-4F72-84E4-FBB686C76A36}" dt="2023-09-20T16:57:01.006" v="371" actId="1037"/>
          <ac:picMkLst>
            <pc:docMk/>
            <pc:sldMk cId="3450577209" sldId="291"/>
            <ac:picMk id="4" creationId="{5B8F14DF-C328-BDE4-BF2F-E6B108A1D220}"/>
          </ac:picMkLst>
        </pc:picChg>
        <pc:picChg chg="mod">
          <ac:chgData name="Martin Carli, Jayne" userId="e3e07b16-903a-4611-9401-85df4cb498fa" providerId="ADAL" clId="{E3C59396-26E5-4F72-84E4-FBB686C76A36}" dt="2023-09-20T16:58:22.170" v="485" actId="1037"/>
          <ac:picMkLst>
            <pc:docMk/>
            <pc:sldMk cId="3450577209" sldId="291"/>
            <ac:picMk id="7" creationId="{27F03C5D-A16C-A614-B80D-44EE0403CE32}"/>
          </ac:picMkLst>
        </pc:picChg>
      </pc:sldChg>
      <pc:sldChg chg="addSp modSp mod modNotesTx">
        <pc:chgData name="Martin Carli, Jayne" userId="e3e07b16-903a-4611-9401-85df4cb498fa" providerId="ADAL" clId="{E3C59396-26E5-4F72-84E4-FBB686C76A36}" dt="2023-09-20T22:25:12.944" v="1320" actId="6549"/>
        <pc:sldMkLst>
          <pc:docMk/>
          <pc:sldMk cId="2300127077" sldId="293"/>
        </pc:sldMkLst>
        <pc:spChg chg="mod">
          <ac:chgData name="Martin Carli, Jayne" userId="e3e07b16-903a-4611-9401-85df4cb498fa" providerId="ADAL" clId="{E3C59396-26E5-4F72-84E4-FBB686C76A36}" dt="2023-09-20T17:19:56.121" v="957" actId="1035"/>
          <ac:spMkLst>
            <pc:docMk/>
            <pc:sldMk cId="2300127077" sldId="293"/>
            <ac:spMk id="2" creationId="{724E2CF5-D6A3-844B-372D-D8A9718FC1AA}"/>
          </ac:spMkLst>
        </pc:spChg>
        <pc:spChg chg="add mod">
          <ac:chgData name="Martin Carli, Jayne" userId="e3e07b16-903a-4611-9401-85df4cb498fa" providerId="ADAL" clId="{E3C59396-26E5-4F72-84E4-FBB686C76A36}" dt="2023-09-20T17:10:26.429" v="924" actId="1038"/>
          <ac:spMkLst>
            <pc:docMk/>
            <pc:sldMk cId="2300127077" sldId="293"/>
            <ac:spMk id="3" creationId="{8E5A3397-34E5-98F2-D110-7E5F7A6357F3}"/>
          </ac:spMkLst>
        </pc:spChg>
        <pc:spChg chg="add mod">
          <ac:chgData name="Martin Carli, Jayne" userId="e3e07b16-903a-4611-9401-85df4cb498fa" providerId="ADAL" clId="{E3C59396-26E5-4F72-84E4-FBB686C76A36}" dt="2023-09-20T17:10:11.163" v="898" actId="1038"/>
          <ac:spMkLst>
            <pc:docMk/>
            <pc:sldMk cId="2300127077" sldId="293"/>
            <ac:spMk id="5" creationId="{E0C6D611-BEF8-E6BC-A7FA-45D883354258}"/>
          </ac:spMkLst>
        </pc:spChg>
        <pc:picChg chg="mod ord">
          <ac:chgData name="Martin Carli, Jayne" userId="e3e07b16-903a-4611-9401-85df4cb498fa" providerId="ADAL" clId="{E3C59396-26E5-4F72-84E4-FBB686C76A36}" dt="2023-09-20T17:12:18.614" v="943" actId="1037"/>
          <ac:picMkLst>
            <pc:docMk/>
            <pc:sldMk cId="2300127077" sldId="293"/>
            <ac:picMk id="4" creationId="{0B1C88EC-9F23-0556-847D-A9A24DEE73C7}"/>
          </ac:picMkLst>
        </pc:picChg>
        <pc:picChg chg="add mod">
          <ac:chgData name="Martin Carli, Jayne" userId="e3e07b16-903a-4611-9401-85df4cb498fa" providerId="ADAL" clId="{E3C59396-26E5-4F72-84E4-FBB686C76A36}" dt="2023-09-20T17:10:11.163" v="898" actId="1038"/>
          <ac:picMkLst>
            <pc:docMk/>
            <pc:sldMk cId="2300127077" sldId="293"/>
            <ac:picMk id="7" creationId="{34BAC310-7228-1793-07FC-37637647F1C2}"/>
          </ac:picMkLst>
        </pc:picChg>
      </pc:sldChg>
      <pc:sldChg chg="del">
        <pc:chgData name="Martin Carli, Jayne" userId="e3e07b16-903a-4611-9401-85df4cb498fa" providerId="ADAL" clId="{E3C59396-26E5-4F72-84E4-FBB686C76A36}" dt="2023-09-15T21:32:08.870" v="0" actId="47"/>
        <pc:sldMkLst>
          <pc:docMk/>
          <pc:sldMk cId="1573493175" sldId="294"/>
        </pc:sldMkLst>
      </pc:sldChg>
      <pc:sldChg chg="addSp modSp mod modNotesTx">
        <pc:chgData name="Martin Carli, Jayne" userId="e3e07b16-903a-4611-9401-85df4cb498fa" providerId="ADAL" clId="{E3C59396-26E5-4F72-84E4-FBB686C76A36}" dt="2023-09-20T22:25:25.211" v="1322" actId="6549"/>
        <pc:sldMkLst>
          <pc:docMk/>
          <pc:sldMk cId="2425510266" sldId="298"/>
        </pc:sldMkLst>
        <pc:spChg chg="mod">
          <ac:chgData name="Martin Carli, Jayne" userId="e3e07b16-903a-4611-9401-85df4cb498fa" providerId="ADAL" clId="{E3C59396-26E5-4F72-84E4-FBB686C76A36}" dt="2023-09-15T21:34:04.892" v="7" actId="207"/>
          <ac:spMkLst>
            <pc:docMk/>
            <pc:sldMk cId="2425510266" sldId="298"/>
            <ac:spMk id="2" creationId="{675B912A-039F-E377-F887-46FA155BC855}"/>
          </ac:spMkLst>
        </pc:spChg>
        <pc:spChg chg="add mod">
          <ac:chgData name="Martin Carli, Jayne" userId="e3e07b16-903a-4611-9401-85df4cb498fa" providerId="ADAL" clId="{E3C59396-26E5-4F72-84E4-FBB686C76A36}" dt="2023-09-20T18:24:45.734" v="1299" actId="1037"/>
          <ac:spMkLst>
            <pc:docMk/>
            <pc:sldMk cId="2425510266" sldId="298"/>
            <ac:spMk id="6" creationId="{E1D390AB-2C15-B225-5FF1-AED0EE30DB73}"/>
          </ac:spMkLst>
        </pc:spChg>
        <pc:spChg chg="add mod">
          <ac:chgData name="Martin Carli, Jayne" userId="e3e07b16-903a-4611-9401-85df4cb498fa" providerId="ADAL" clId="{E3C59396-26E5-4F72-84E4-FBB686C76A36}" dt="2023-09-20T18:24:53.490" v="1315" actId="1038"/>
          <ac:spMkLst>
            <pc:docMk/>
            <pc:sldMk cId="2425510266" sldId="298"/>
            <ac:spMk id="7" creationId="{7B521FD3-425C-32B2-845E-144CFCB0B4C3}"/>
          </ac:spMkLst>
        </pc:spChg>
        <pc:picChg chg="add mod">
          <ac:chgData name="Martin Carli, Jayne" userId="e3e07b16-903a-4611-9401-85df4cb498fa" providerId="ADAL" clId="{E3C59396-26E5-4F72-84E4-FBB686C76A36}" dt="2023-09-20T18:24:20.176" v="1251" actId="14100"/>
          <ac:picMkLst>
            <pc:docMk/>
            <pc:sldMk cId="2425510266" sldId="298"/>
            <ac:picMk id="4" creationId="{6A30E774-3F3B-5B34-C0AF-B6D7507E8668}"/>
          </ac:picMkLst>
        </pc:picChg>
        <pc:picChg chg="mod">
          <ac:chgData name="Martin Carli, Jayne" userId="e3e07b16-903a-4611-9401-85df4cb498fa" providerId="ADAL" clId="{E3C59396-26E5-4F72-84E4-FBB686C76A36}" dt="2023-09-20T18:24:20.176" v="1251" actId="14100"/>
          <ac:picMkLst>
            <pc:docMk/>
            <pc:sldMk cId="2425510266" sldId="298"/>
            <ac:picMk id="5" creationId="{60C3D116-67ED-84E7-0E34-CA9167D25254}"/>
          </ac:picMkLst>
        </pc:picChg>
      </pc:sldChg>
      <pc:sldChg chg="del">
        <pc:chgData name="Martin Carli, Jayne" userId="e3e07b16-903a-4611-9401-85df4cb498fa" providerId="ADAL" clId="{E3C59396-26E5-4F72-84E4-FBB686C76A36}" dt="2023-09-15T21:32:08.870" v="0" actId="47"/>
        <pc:sldMkLst>
          <pc:docMk/>
          <pc:sldMk cId="1694624340" sldId="299"/>
        </pc:sldMkLst>
      </pc:sldChg>
      <pc:sldChg chg="addSp modSp mod">
        <pc:chgData name="Martin Carli, Jayne" userId="e3e07b16-903a-4611-9401-85df4cb498fa" providerId="ADAL" clId="{E3C59396-26E5-4F72-84E4-FBB686C76A36}" dt="2023-09-20T17:01:06.988" v="787" actId="1036"/>
        <pc:sldMkLst>
          <pc:docMk/>
          <pc:sldMk cId="2224574114" sldId="300"/>
        </pc:sldMkLst>
        <pc:spChg chg="add mod">
          <ac:chgData name="Martin Carli, Jayne" userId="e3e07b16-903a-4611-9401-85df4cb498fa" providerId="ADAL" clId="{E3C59396-26E5-4F72-84E4-FBB686C76A36}" dt="2023-09-20T17:01:06.988" v="787" actId="1036"/>
          <ac:spMkLst>
            <pc:docMk/>
            <pc:sldMk cId="2224574114" sldId="300"/>
            <ac:spMk id="2" creationId="{F215A92C-0350-DE8E-02F3-9062D73C4962}"/>
          </ac:spMkLst>
        </pc:spChg>
        <pc:spChg chg="add mod">
          <ac:chgData name="Martin Carli, Jayne" userId="e3e07b16-903a-4611-9401-85df4cb498fa" providerId="ADAL" clId="{E3C59396-26E5-4F72-84E4-FBB686C76A36}" dt="2023-09-20T17:01:06.988" v="787" actId="1036"/>
          <ac:spMkLst>
            <pc:docMk/>
            <pc:sldMk cId="2224574114" sldId="300"/>
            <ac:spMk id="4" creationId="{F3DDA439-E6B1-023F-CBCE-003D67A74082}"/>
          </ac:spMkLst>
        </pc:spChg>
        <pc:spChg chg="mod">
          <ac:chgData name="Martin Carli, Jayne" userId="e3e07b16-903a-4611-9401-85df4cb498fa" providerId="ADAL" clId="{E3C59396-26E5-4F72-84E4-FBB686C76A36}" dt="2023-09-20T17:00:46.861" v="780" actId="20577"/>
          <ac:spMkLst>
            <pc:docMk/>
            <pc:sldMk cId="2224574114" sldId="300"/>
            <ac:spMk id="5" creationId="{1BDC8EA6-36E4-E102-3844-897A0B69760F}"/>
          </ac:spMkLst>
        </pc:spChg>
        <pc:picChg chg="mod">
          <ac:chgData name="Martin Carli, Jayne" userId="e3e07b16-903a-4611-9401-85df4cb498fa" providerId="ADAL" clId="{E3C59396-26E5-4F72-84E4-FBB686C76A36}" dt="2023-09-20T17:00:36.265" v="766" actId="14100"/>
          <ac:picMkLst>
            <pc:docMk/>
            <pc:sldMk cId="2224574114" sldId="300"/>
            <ac:picMk id="3" creationId="{2BC8D227-7D03-F3B0-5F40-E9DE0022B5AC}"/>
          </ac:picMkLst>
        </pc:picChg>
        <pc:picChg chg="add mod">
          <ac:chgData name="Martin Carli, Jayne" userId="e3e07b16-903a-4611-9401-85df4cb498fa" providerId="ADAL" clId="{E3C59396-26E5-4F72-84E4-FBB686C76A36}" dt="2023-09-20T17:00:39.531" v="777" actId="1038"/>
          <ac:picMkLst>
            <pc:docMk/>
            <pc:sldMk cId="2224574114" sldId="300"/>
            <ac:picMk id="7" creationId="{FBF7B8B9-D78D-0529-1FDB-024D5681FE63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F8C56CC7-F108-4F96-B1F0-98391359576E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77875" y="1200150"/>
            <a:ext cx="5759450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A25ED2AC-2EC9-4C82-B834-AE146A5E49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4777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9540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11604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17799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9575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63587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15172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73640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09324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06505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09414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86171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5ED2AC-2EC9-4C82-B834-AE146A5E491A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7955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53638D-B10B-3D42-BB20-960032273B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C600FBA-9ED1-5300-6B49-8EB9192E71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A5EBFC-50B8-05B9-9455-2FEB21672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9ECCFC-EFEA-5B77-EEA7-372BD697B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360E67-4E68-4602-3721-F891BF5F03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183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E72AD2-5301-C697-FA01-F9524D3755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8B5141-BF30-AB4D-952C-89E75164A7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B31C13-CD22-4337-AE68-229EBB192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738F0A-C418-D073-FD87-DAC75927F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B9A2BD-B0F6-6087-1986-02D098BD3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9603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99D957-3D86-8FEE-DD8F-5C3566E698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6B9F54-9784-D752-95DA-89E98DC441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BA08FC-A774-1E39-A762-4667EF676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8BED8D-4AB9-2F8D-99BE-2EE6330BF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7E9C95-4224-C110-FC1C-F71C6305E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609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FF288A-FADC-84C5-0828-3603B64482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320AF5-D8B1-9372-82E2-D2C95A3A8F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574281-E612-AE9A-3F64-C3608BEB3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D19F09-79C4-C226-64BE-7BB3C826E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94061-B3F5-54F7-3931-BB4F55B69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021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0FAB46-5740-02D5-C741-E05F4FB70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9E658A-B171-6E21-F420-4F5D7FD9E9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8368E1-F53A-1D1E-460E-38F8DCDBD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5CE2E9-D159-76B0-1C20-A97113308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DEEE82-1248-9072-F811-A970F78A5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600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E134ED-4F92-E08C-BC42-A38F371567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A1C5E2-80B2-C9CB-D763-42FCC38691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6902D1-6BBA-1AA5-1855-FA653547FF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0DE231-535E-B897-53D5-6CBDECA4BB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872006-A6D6-C7E5-BB1D-8A47AF8C80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9DBDE7-4F28-C209-194D-48F92D851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044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2866FD-1436-DE47-C433-EF8B687B75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13B93A-4C4D-E52B-64FF-1134747892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FB1AC89-DAEB-9590-F8DC-EF1ACF8C21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C4F14A7-DD99-67E5-1DC5-4F77738E0B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1639A53-DF81-774F-07AB-A35706DA62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AEAAA6A-0B51-E10A-2C28-526E32FCDE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B0AE8A-C93E-7F23-5534-E029E9654A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13CE811-9E91-D2B8-5F0A-49024C36C4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018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99823E-85AE-503E-8713-92811DCBC6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BEA71E-5AE9-1DF3-F453-C0054E213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761BF6-44B2-491E-8DDD-086DC411D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D2E8721-1D55-AEFD-5B8C-3917D5490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807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077F67E-4B1C-B61F-3E48-4F3C52765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100594-AD75-C374-AE8A-57600244E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A90BFB-2608-A30C-2970-FECE321FE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9846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9D0728-7F44-97E4-A68C-FA3B086D63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A3A127-1F4A-1A54-C5A7-E37A87FC6D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2ACBBC-5C0F-7AC7-6DAA-006BC5620B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C3D949-0217-0664-8B42-4876030477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234FF6-43FA-1959-F66B-D2C364B46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724B12-A25D-018C-07B9-E2065C072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651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A505BC-50E8-AC93-2189-AE8DE4A0A9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744186-A18F-9F83-802E-B6DD83399E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DF3A26-4EE6-3250-03FF-D3C774657D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C46085-AE71-3F8E-CA1E-BF44EB782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1672D3-FFBF-458B-AAC3-F903B621C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D62D0D-3BC0-EC6C-614E-2DBF7BBEE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070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1DD106C-BF59-2E7C-7A56-6D6340A1A0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B9C03A-23B5-2B58-6660-1C5161C17A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632C9A-FF61-5527-1AF7-84B10AE20C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D834D6-44AD-43D3-A055-B8C5EF2EC797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4D739B-03E7-6CC7-2CF9-E58754DB42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5FCCEC-9178-CE05-E290-4B6A57CE34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F66A49-C91C-4A9A-BDD3-B20447BF95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381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A84E89A-9145-16E0-0136-A684B0CED29C}"/>
              </a:ext>
            </a:extLst>
          </p:cNvPr>
          <p:cNvSpPr txBox="1"/>
          <p:nvPr/>
        </p:nvSpPr>
        <p:spPr>
          <a:xfrm>
            <a:off x="0" y="0"/>
            <a:ext cx="2396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AE40878-BAAA-9CAC-C27E-651C3F495A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9678" y="726882"/>
            <a:ext cx="3832860" cy="2987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760909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0216F42-E512-606B-9CA0-1B47DBEB85CF}"/>
              </a:ext>
            </a:extLst>
          </p:cNvPr>
          <p:cNvSpPr txBox="1"/>
          <p:nvPr/>
        </p:nvSpPr>
        <p:spPr>
          <a:xfrm>
            <a:off x="0" y="0"/>
            <a:ext cx="31466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l Figure 10 – Hs </a:t>
            </a:r>
          </a:p>
        </p:txBody>
      </p:sp>
      <p:pic>
        <p:nvPicPr>
          <p:cNvPr id="5" name="Picture 4" descr="A diagram of a cell&#10;&#10;Description automatically generated">
            <a:extLst>
              <a:ext uri="{FF2B5EF4-FFF2-40B4-BE49-F238E27FC236}">
                <a16:creationId xmlns:a16="http://schemas.microsoft.com/office/drawing/2014/main" id="{54382C7E-B210-F1E2-8504-62CCE96098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4361"/>
            <a:ext cx="12192000" cy="65892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539545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90DDFA2-96D8-D71F-08F4-BA78BFF725D6}"/>
              </a:ext>
            </a:extLst>
          </p:cNvPr>
          <p:cNvSpPr txBox="1"/>
          <p:nvPr/>
        </p:nvSpPr>
        <p:spPr>
          <a:xfrm>
            <a:off x="-1" y="0"/>
            <a:ext cx="30659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l Figure 11 – Mm</a:t>
            </a:r>
          </a:p>
        </p:txBody>
      </p:sp>
      <p:pic>
        <p:nvPicPr>
          <p:cNvPr id="5" name="Picture 4" descr="A diagram of a cell&#10;&#10;Description automatically generated">
            <a:extLst>
              <a:ext uri="{FF2B5EF4-FFF2-40B4-BE49-F238E27FC236}">
                <a16:creationId xmlns:a16="http://schemas.microsoft.com/office/drawing/2014/main" id="{ACD11A57-23E0-35BD-47EE-E3E023AF8F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4361"/>
            <a:ext cx="12192000" cy="65892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458733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EEDBFAE8-CA5A-18F5-5DDF-782EC2240808}"/>
              </a:ext>
            </a:extLst>
          </p:cNvPr>
          <p:cNvSpPr txBox="1"/>
          <p:nvPr/>
        </p:nvSpPr>
        <p:spPr>
          <a:xfrm>
            <a:off x="0" y="0"/>
            <a:ext cx="24608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l Figure 12</a:t>
            </a:r>
          </a:p>
        </p:txBody>
      </p:sp>
      <p:pic>
        <p:nvPicPr>
          <p:cNvPr id="6" name="Picture 5" descr="A rectangular object with different colored squares&#10;&#10;Description automatically generated with medium confidence">
            <a:extLst>
              <a:ext uri="{FF2B5EF4-FFF2-40B4-BE49-F238E27FC236}">
                <a16:creationId xmlns:a16="http://schemas.microsoft.com/office/drawing/2014/main" id="{6DAA0C33-CCB7-426D-9541-7902AD6B938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1" r="-249"/>
          <a:stretch/>
        </p:blipFill>
        <p:spPr>
          <a:xfrm>
            <a:off x="-1" y="1981200"/>
            <a:ext cx="12235914" cy="20192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36472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2430E71-C543-739F-7D7E-E3CA13F2D463}"/>
              </a:ext>
            </a:extLst>
          </p:cNvPr>
          <p:cNvSpPr txBox="1"/>
          <p:nvPr/>
        </p:nvSpPr>
        <p:spPr>
          <a:xfrm>
            <a:off x="0" y="0"/>
            <a:ext cx="2396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l Figure 2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224BEDA-6AE1-7284-50E0-DBE113EAF5CF}"/>
              </a:ext>
            </a:extLst>
          </p:cNvPr>
          <p:cNvSpPr txBox="1"/>
          <p:nvPr/>
        </p:nvSpPr>
        <p:spPr>
          <a:xfrm>
            <a:off x="54775" y="642422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DA55F0A-51FB-5D98-3433-05CBAED4562D}"/>
              </a:ext>
            </a:extLst>
          </p:cNvPr>
          <p:cNvSpPr txBox="1"/>
          <p:nvPr/>
        </p:nvSpPr>
        <p:spPr>
          <a:xfrm>
            <a:off x="39156" y="3040936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A51F537-07A6-134E-425E-B5A0EE296F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4932511"/>
              </p:ext>
            </p:extLst>
          </p:nvPr>
        </p:nvGraphicFramePr>
        <p:xfrm>
          <a:off x="327093" y="331073"/>
          <a:ext cx="9410700" cy="2709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9411005" imgH="2709431" progId="Prism10.Document">
                  <p:embed/>
                </p:oleObj>
              </mc:Choice>
              <mc:Fallback>
                <p:oleObj name="Prism 10" r:id="rId3" imgW="9411005" imgH="2709431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A51F537-07A6-134E-425E-B5A0EE296F5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27093" y="331073"/>
                        <a:ext cx="9410700" cy="2709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EAB1861C-6941-297D-9A4A-C62A150D6C9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9420" y="3429000"/>
            <a:ext cx="4960620" cy="2560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02468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CB23911-BEA4-25D7-22E8-3B34EE3172A9}"/>
              </a:ext>
            </a:extLst>
          </p:cNvPr>
          <p:cNvSpPr txBox="1"/>
          <p:nvPr/>
        </p:nvSpPr>
        <p:spPr>
          <a:xfrm>
            <a:off x="0" y="0"/>
            <a:ext cx="15342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</a:t>
            </a:r>
          </a:p>
          <a:p>
            <a:r>
              <a:rPr lang="en-US" dirty="0"/>
              <a:t>Figure 3 </a:t>
            </a:r>
          </a:p>
        </p:txBody>
      </p:sp>
      <p:pic>
        <p:nvPicPr>
          <p:cNvPr id="5" name="Picture 4" descr="A screen shot of a computer code&#10;&#10;Description automatically generated">
            <a:extLst>
              <a:ext uri="{FF2B5EF4-FFF2-40B4-BE49-F238E27FC236}">
                <a16:creationId xmlns:a16="http://schemas.microsoft.com/office/drawing/2014/main" id="{60F9D07E-3A63-4249-5F13-1067120E6A2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0721" y="0"/>
            <a:ext cx="4608044" cy="6858000"/>
          </a:xfrm>
          <a:prstGeom prst="rect">
            <a:avLst/>
          </a:prstGeom>
        </p:spPr>
      </p:pic>
      <p:pic>
        <p:nvPicPr>
          <p:cNvPr id="4" name="Picture 3" descr="A vertical line of text&#10;&#10;Description automatically generated with medium confidence">
            <a:extLst>
              <a:ext uri="{FF2B5EF4-FFF2-40B4-BE49-F238E27FC236}">
                <a16:creationId xmlns:a16="http://schemas.microsoft.com/office/drawing/2014/main" id="{07B7F900-8E2A-4353-700E-9E3AC24B7A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4278" y="0"/>
            <a:ext cx="4608044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6229801-2446-CA77-A4EA-488A71E5D9AE}"/>
              </a:ext>
            </a:extLst>
          </p:cNvPr>
          <p:cNvSpPr txBox="1"/>
          <p:nvPr/>
        </p:nvSpPr>
        <p:spPr>
          <a:xfrm>
            <a:off x="1549885" y="-23084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2DAE36E-E388-6646-8783-BA2E6B826488}"/>
              </a:ext>
            </a:extLst>
          </p:cNvPr>
          <p:cNvSpPr txBox="1"/>
          <p:nvPr/>
        </p:nvSpPr>
        <p:spPr>
          <a:xfrm>
            <a:off x="6665838" y="-23084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003143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411F78C-2148-7935-E88F-95153F28CFB2}"/>
              </a:ext>
            </a:extLst>
          </p:cNvPr>
          <p:cNvSpPr txBox="1"/>
          <p:nvPr/>
        </p:nvSpPr>
        <p:spPr>
          <a:xfrm>
            <a:off x="0" y="0"/>
            <a:ext cx="15342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</a:t>
            </a:r>
          </a:p>
          <a:p>
            <a:r>
              <a:rPr lang="en-US" dirty="0"/>
              <a:t>Figure 4 </a:t>
            </a:r>
          </a:p>
        </p:txBody>
      </p:sp>
      <p:pic>
        <p:nvPicPr>
          <p:cNvPr id="7" name="Picture 6" descr="A black and white text&#10;&#10;Description automatically generated with medium confidence">
            <a:extLst>
              <a:ext uri="{FF2B5EF4-FFF2-40B4-BE49-F238E27FC236}">
                <a16:creationId xmlns:a16="http://schemas.microsoft.com/office/drawing/2014/main" id="{27F03C5D-A16C-A614-B80D-44EE0403CE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1085" y="0"/>
            <a:ext cx="5327530" cy="6858000"/>
          </a:xfrm>
          <a:prstGeom prst="rect">
            <a:avLst/>
          </a:prstGeom>
        </p:spPr>
      </p:pic>
      <p:pic>
        <p:nvPicPr>
          <p:cNvPr id="4" name="Picture 3" descr="A long vertical line of text&#10;&#10;Description automatically generated with medium confidence">
            <a:extLst>
              <a:ext uri="{FF2B5EF4-FFF2-40B4-BE49-F238E27FC236}">
                <a16:creationId xmlns:a16="http://schemas.microsoft.com/office/drawing/2014/main" id="{5B8F14DF-C328-BDE4-BF2F-E6B108A1D2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49114" y="0"/>
            <a:ext cx="4504072" cy="685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3C4C56A-F199-E778-E922-7FAF3E104E67}"/>
              </a:ext>
            </a:extLst>
          </p:cNvPr>
          <p:cNvSpPr txBox="1"/>
          <p:nvPr/>
        </p:nvSpPr>
        <p:spPr>
          <a:xfrm>
            <a:off x="1549885" y="-23084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C6F6EC-901D-7220-0624-01AB25EDD898}"/>
              </a:ext>
            </a:extLst>
          </p:cNvPr>
          <p:cNvSpPr txBox="1"/>
          <p:nvPr/>
        </p:nvSpPr>
        <p:spPr>
          <a:xfrm>
            <a:off x="6665838" y="-23084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4505772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24E2CF5-D6A3-844B-372D-D8A9718FC1AA}"/>
              </a:ext>
            </a:extLst>
          </p:cNvPr>
          <p:cNvSpPr txBox="1"/>
          <p:nvPr/>
        </p:nvSpPr>
        <p:spPr>
          <a:xfrm>
            <a:off x="-76200" y="-85725"/>
            <a:ext cx="15342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</a:t>
            </a:r>
          </a:p>
          <a:p>
            <a:r>
              <a:rPr lang="en-US" dirty="0"/>
              <a:t>Figure 5 </a:t>
            </a:r>
          </a:p>
        </p:txBody>
      </p:sp>
      <p:pic>
        <p:nvPicPr>
          <p:cNvPr id="4" name="Picture 3" descr="A long vertical line of text&#10;&#10;Description automatically generated with medium confidence">
            <a:extLst>
              <a:ext uri="{FF2B5EF4-FFF2-40B4-BE49-F238E27FC236}">
                <a16:creationId xmlns:a16="http://schemas.microsoft.com/office/drawing/2014/main" id="{0B1C88EC-9F23-0556-847D-A9A24DEE73C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5335" y="0"/>
            <a:ext cx="5327530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E5A3397-34E5-98F2-D110-7E5F7A6357F3}"/>
              </a:ext>
            </a:extLst>
          </p:cNvPr>
          <p:cNvSpPr txBox="1"/>
          <p:nvPr/>
        </p:nvSpPr>
        <p:spPr>
          <a:xfrm>
            <a:off x="1292710" y="-23084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0C6D611-BEF8-E6BC-A7FA-45D883354258}"/>
              </a:ext>
            </a:extLst>
          </p:cNvPr>
          <p:cNvSpPr txBox="1"/>
          <p:nvPr/>
        </p:nvSpPr>
        <p:spPr>
          <a:xfrm>
            <a:off x="6570588" y="-23084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" name="Picture 6" descr="A long shot of a text&#10;&#10;Description automatically generated with medium confidence">
            <a:extLst>
              <a:ext uri="{FF2B5EF4-FFF2-40B4-BE49-F238E27FC236}">
                <a16:creationId xmlns:a16="http://schemas.microsoft.com/office/drawing/2014/main" id="{34BAC310-7228-1793-07FC-37637647F1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61235" y="0"/>
            <a:ext cx="532753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01270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graph&#10;&#10;Description automatically generated">
            <a:extLst>
              <a:ext uri="{FF2B5EF4-FFF2-40B4-BE49-F238E27FC236}">
                <a16:creationId xmlns:a16="http://schemas.microsoft.com/office/drawing/2014/main" id="{2BC8D227-7D03-F3B0-5F40-E9DE0022B5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4" y="646330"/>
            <a:ext cx="5688834" cy="621166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BDC8EA6-36E4-E102-3844-897A0B69760F}"/>
              </a:ext>
            </a:extLst>
          </p:cNvPr>
          <p:cNvSpPr txBox="1"/>
          <p:nvPr/>
        </p:nvSpPr>
        <p:spPr>
          <a:xfrm>
            <a:off x="0" y="0"/>
            <a:ext cx="2339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6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215A92C-0350-DE8E-02F3-9062D73C4962}"/>
              </a:ext>
            </a:extLst>
          </p:cNvPr>
          <p:cNvSpPr txBox="1"/>
          <p:nvPr/>
        </p:nvSpPr>
        <p:spPr>
          <a:xfrm>
            <a:off x="10960" y="384348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3DDA439-E6B1-023F-CBCE-003D67A74082}"/>
              </a:ext>
            </a:extLst>
          </p:cNvPr>
          <p:cNvSpPr txBox="1"/>
          <p:nvPr/>
        </p:nvSpPr>
        <p:spPr>
          <a:xfrm>
            <a:off x="5663903" y="384348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" name="Picture 6" descr="A graph of a number of text&#10;&#10;Description automatically generated with medium confidence">
            <a:extLst>
              <a:ext uri="{FF2B5EF4-FFF2-40B4-BE49-F238E27FC236}">
                <a16:creationId xmlns:a16="http://schemas.microsoft.com/office/drawing/2014/main" id="{FBF7B8B9-D78D-0529-1FDB-024D5681FE6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63903" y="646330"/>
            <a:ext cx="6548262" cy="62116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457411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14C5E1A-2F39-B101-2728-2DCD2E897780}"/>
              </a:ext>
            </a:extLst>
          </p:cNvPr>
          <p:cNvSpPr txBox="1"/>
          <p:nvPr/>
        </p:nvSpPr>
        <p:spPr>
          <a:xfrm>
            <a:off x="0" y="0"/>
            <a:ext cx="15342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</a:t>
            </a:r>
          </a:p>
          <a:p>
            <a:r>
              <a:rPr lang="en-US" dirty="0"/>
              <a:t>Figure 7 </a:t>
            </a:r>
          </a:p>
        </p:txBody>
      </p:sp>
      <p:pic>
        <p:nvPicPr>
          <p:cNvPr id="5" name="Picture 4" descr="A close-up of a number&#10;&#10;Description automatically generated">
            <a:extLst>
              <a:ext uri="{FF2B5EF4-FFF2-40B4-BE49-F238E27FC236}">
                <a16:creationId xmlns:a16="http://schemas.microsoft.com/office/drawing/2014/main" id="{9A51E6EE-AF4E-AEA6-7141-F011CB1D91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4719" y="0"/>
            <a:ext cx="4616361" cy="6858000"/>
          </a:xfrm>
          <a:prstGeom prst="rect">
            <a:avLst/>
          </a:prstGeom>
        </p:spPr>
      </p:pic>
      <p:pic>
        <p:nvPicPr>
          <p:cNvPr id="4" name="Picture 3" descr="A screen shot of a computer code&#10;&#10;Description automatically generated">
            <a:extLst>
              <a:ext uri="{FF2B5EF4-FFF2-40B4-BE49-F238E27FC236}">
                <a16:creationId xmlns:a16="http://schemas.microsoft.com/office/drawing/2014/main" id="{2E4CEA99-348A-222B-C10C-E89E3AA913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50119" y="0"/>
            <a:ext cx="4616361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F77C1EE-9C65-89F9-DEC5-703D3DC5E2C8}"/>
              </a:ext>
            </a:extLst>
          </p:cNvPr>
          <p:cNvSpPr txBox="1"/>
          <p:nvPr/>
        </p:nvSpPr>
        <p:spPr>
          <a:xfrm>
            <a:off x="1549885" y="-23084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0ACD376-0782-7D76-FED4-73754EE7B10B}"/>
              </a:ext>
            </a:extLst>
          </p:cNvPr>
          <p:cNvSpPr txBox="1"/>
          <p:nvPr/>
        </p:nvSpPr>
        <p:spPr>
          <a:xfrm>
            <a:off x="6665838" y="-23084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630078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75B912A-039F-E377-F887-46FA155BC855}"/>
              </a:ext>
            </a:extLst>
          </p:cNvPr>
          <p:cNvSpPr txBox="1"/>
          <p:nvPr/>
        </p:nvSpPr>
        <p:spPr>
          <a:xfrm>
            <a:off x="0" y="0"/>
            <a:ext cx="23968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8 </a:t>
            </a:r>
          </a:p>
        </p:txBody>
      </p:sp>
      <p:pic>
        <p:nvPicPr>
          <p:cNvPr id="5" name="Picture 4" descr="A screen shot of a computer code&#10;&#10;Description automatically generated">
            <a:extLst>
              <a:ext uri="{FF2B5EF4-FFF2-40B4-BE49-F238E27FC236}">
                <a16:creationId xmlns:a16="http://schemas.microsoft.com/office/drawing/2014/main" id="{60C3D116-67ED-84E7-0E34-CA9167D2525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4280" y="369332"/>
            <a:ext cx="5697751" cy="6488668"/>
          </a:xfrm>
          <a:prstGeom prst="rect">
            <a:avLst/>
          </a:prstGeom>
        </p:spPr>
      </p:pic>
      <p:pic>
        <p:nvPicPr>
          <p:cNvPr id="4" name="Picture 3" descr="A close-up of a text&#10;&#10;Description automatically generated">
            <a:extLst>
              <a:ext uri="{FF2B5EF4-FFF2-40B4-BE49-F238E27FC236}">
                <a16:creationId xmlns:a16="http://schemas.microsoft.com/office/drawing/2014/main" id="{6A30E774-3F3B-5B34-C0AF-B6D7507E86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41808" y="369332"/>
            <a:ext cx="4761242" cy="648866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1D390AB-2C15-B225-5FF1-AED0EE30DB73}"/>
              </a:ext>
            </a:extLst>
          </p:cNvPr>
          <p:cNvSpPr txBox="1"/>
          <p:nvPr/>
        </p:nvSpPr>
        <p:spPr>
          <a:xfrm>
            <a:off x="1230160" y="317673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B521FD3-425C-32B2-845E-144CFCB0B4C3}"/>
              </a:ext>
            </a:extLst>
          </p:cNvPr>
          <p:cNvSpPr txBox="1"/>
          <p:nvPr/>
        </p:nvSpPr>
        <p:spPr>
          <a:xfrm>
            <a:off x="7178378" y="317673"/>
            <a:ext cx="261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255102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2641452-BD79-1A3B-3982-08B05887DC5F}"/>
              </a:ext>
            </a:extLst>
          </p:cNvPr>
          <p:cNvSpPr txBox="1"/>
          <p:nvPr/>
        </p:nvSpPr>
        <p:spPr>
          <a:xfrm>
            <a:off x="29459" y="-24678"/>
            <a:ext cx="268684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upplemental Figure 9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08A723C-D330-0697-1C6A-C07F65431251}"/>
              </a:ext>
            </a:extLst>
          </p:cNvPr>
          <p:cNvSpPr txBox="1"/>
          <p:nvPr/>
        </p:nvSpPr>
        <p:spPr>
          <a:xfrm>
            <a:off x="1078330" y="184666"/>
            <a:ext cx="3333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5815400-34E9-1D71-BD32-F75662E84083}"/>
              </a:ext>
            </a:extLst>
          </p:cNvPr>
          <p:cNvSpPr txBox="1"/>
          <p:nvPr/>
        </p:nvSpPr>
        <p:spPr>
          <a:xfrm>
            <a:off x="1078330" y="3429000"/>
            <a:ext cx="3333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/>
              <a:t>B</a:t>
            </a:r>
          </a:p>
        </p:txBody>
      </p:sp>
      <p:pic>
        <p:nvPicPr>
          <p:cNvPr id="9" name="Picture 8" descr="A screenshot of a computer&#10;&#10;Description automatically generated">
            <a:extLst>
              <a:ext uri="{FF2B5EF4-FFF2-40B4-BE49-F238E27FC236}">
                <a16:creationId xmlns:a16="http://schemas.microsoft.com/office/drawing/2014/main" id="{8E212757-6148-F8A8-D151-1201D268865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1704" y="318599"/>
            <a:ext cx="9150323" cy="3266337"/>
          </a:xfrm>
          <a:prstGeom prst="rect">
            <a:avLst/>
          </a:prstGeom>
        </p:spPr>
      </p:pic>
      <p:pic>
        <p:nvPicPr>
          <p:cNvPr id="11" name="Picture 10" descr="A screenshot of a computer&#10;&#10;Description automatically generated">
            <a:extLst>
              <a:ext uri="{FF2B5EF4-FFF2-40B4-BE49-F238E27FC236}">
                <a16:creationId xmlns:a16="http://schemas.microsoft.com/office/drawing/2014/main" id="{039060B6-C29F-E4C5-2A24-E87F50BA0C0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7185" y="3544103"/>
            <a:ext cx="9150323" cy="32663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6555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60</TotalTime>
  <Words>68</Words>
  <Application>Microsoft Office PowerPoint</Application>
  <PresentationFormat>Widescreen</PresentationFormat>
  <Paragraphs>44</Paragraphs>
  <Slides>12</Slides>
  <Notes>1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Carli, Jayne</dc:creator>
  <cp:lastModifiedBy>Martin Carli, Jayne</cp:lastModifiedBy>
  <cp:revision>3</cp:revision>
  <cp:lastPrinted>2023-09-15T21:31:05Z</cp:lastPrinted>
  <dcterms:created xsi:type="dcterms:W3CDTF">2023-01-10T17:38:10Z</dcterms:created>
  <dcterms:modified xsi:type="dcterms:W3CDTF">2023-09-20T22:25:49Z</dcterms:modified>
</cp:coreProperties>
</file>